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3" r:id="rId2"/>
    <p:sldId id="314" r:id="rId3"/>
    <p:sldId id="315" r:id="rId4"/>
    <p:sldId id="316" r:id="rId5"/>
    <p:sldId id="317" r:id="rId6"/>
    <p:sldId id="318" r:id="rId7"/>
    <p:sldId id="319" r:id="rId8"/>
    <p:sldId id="320" r:id="rId9"/>
    <p:sldId id="321" r:id="rId10"/>
    <p:sldId id="322" r:id="rId11"/>
    <p:sldId id="323" r:id="rId12"/>
    <p:sldId id="324" r:id="rId13"/>
    <p:sldId id="301" r:id="rId14"/>
    <p:sldId id="302" r:id="rId15"/>
    <p:sldId id="303" r:id="rId16"/>
    <p:sldId id="304" r:id="rId17"/>
    <p:sldId id="305" r:id="rId18"/>
    <p:sldId id="306" r:id="rId1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n, Huang" initials="LH" lastIdx="2" clrIdx="0"/>
  <p:cmAuthor id="2" name="Yue" initials="Y" lastIdx="0" clrIdx="1"/>
  <p:cmAuthor id="3" name="Peddada, Shyamal (NIH/NICHD) [E]" initials="PS([" lastIdx="3" clrIdx="2"/>
  <p:cmAuthor id="4" name="Rinaldo Jr, Charles" initials="RJC" lastIdx="2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326" autoAdjust="0"/>
    <p:restoredTop sz="94662" autoAdjust="0"/>
  </p:normalViewPr>
  <p:slideViewPr>
    <p:cSldViewPr>
      <p:cViewPr>
        <p:scale>
          <a:sx n="126" d="100"/>
          <a:sy n="126" d="100"/>
        </p:scale>
        <p:origin x="-1530" y="-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commentAuthors" Target="comment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365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952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458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483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015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894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669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540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13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149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383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36B0BD-2ED7-4D16-AD2A-636804446FBA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5E875B-C959-4713-B7E8-ED7FED9E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707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1. The log fold change (LFC) of absolute abundances for differentially abundant families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82C56E59-939F-0F4F-9282-BBC491FAEEC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31769313"/>
              </p:ext>
            </p:extLst>
          </p:nvPr>
        </p:nvGraphicFramePr>
        <p:xfrm>
          <a:off x="457200" y="1981200"/>
          <a:ext cx="8229600" cy="424491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371600">
                  <a:extLst>
                    <a:ext uri="{9D8B030D-6E8A-4147-A177-3AD203B41FA5}">
                      <a16:colId xmlns="" xmlns:a16="http://schemas.microsoft.com/office/drawing/2014/main" val="3831745218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184954486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4006536893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659126051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4043309444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976700242"/>
                    </a:ext>
                  </a:extLst>
                </a:gridCol>
              </a:tblGrid>
              <a:tr h="366051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 </a:t>
                      </a:r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minus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NC at visit 1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69407761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442805080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Succinivibrion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3, 1.88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468353740"/>
                  </a:ext>
                </a:extLst>
              </a:tr>
              <a:tr h="198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S24-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4, 1.39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862561140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[Mogibacteriaceae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33, 0.98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132377432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Coriobacteri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, 0.98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596189829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Erysipelotrich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1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9, 0.78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106177408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[Odoribacteraceae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0.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0.95, -0.09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12648758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Verrucomicrobi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0.9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62, -0.35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43228901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Bacteroid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1.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58, -0.53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76595452"/>
                  </a:ext>
                </a:extLst>
              </a:tr>
              <a:tr h="36789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[Barnesiellaceae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1.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71, -0.61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962056223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Rikenell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1.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80, -0.63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52338112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29540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1187722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200" y="2000727"/>
          <a:ext cx="8229599" cy="1550366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5240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1143000">
                  <a:extLst>
                    <a:ext uri="{9D8B030D-6E8A-4147-A177-3AD203B41FA5}">
                      <a16:colId xmlns="" xmlns:a16="http://schemas.microsoft.com/office/drawing/2014/main" val="2288077139"/>
                    </a:ext>
                  </a:extLst>
                </a:gridCol>
                <a:gridCol w="10668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968828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&lt; 5 Years minus &gt; 10 Years in SC at Visit 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u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anobacteri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anosphaer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0, 1.13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Eubacterium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50, -0.04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1789118009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447800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2. The log fold change (LFC) of absolute abundances for differentially abundant genera</a:t>
            </a:r>
          </a:p>
        </p:txBody>
      </p:sp>
    </p:spTree>
    <p:extLst>
      <p:ext uri="{BB962C8B-B14F-4D97-AF65-F5344CB8AC3E}">
        <p14:creationId xmlns:p14="http://schemas.microsoft.com/office/powerpoint/2010/main" val="22717360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081842779"/>
              </p:ext>
            </p:extLst>
          </p:nvPr>
        </p:nvGraphicFramePr>
        <p:xfrm>
          <a:off x="457200" y="2000727"/>
          <a:ext cx="8229599" cy="2472082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2954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1219200">
                  <a:extLst>
                    <a:ext uri="{9D8B030D-6E8A-4147-A177-3AD203B41FA5}">
                      <a16:colId xmlns="" xmlns:a16="http://schemas.microsoft.com/office/drawing/2014/main" val="4129887343"/>
                    </a:ext>
                  </a:extLst>
                </a:gridCol>
                <a:gridCol w="1012371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&lt; 5 Years minus &gt; 10 Years in SC at Visit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u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votell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votell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51, 3.89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minococc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ecalibacterium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2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02, -0.02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336123078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illonell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erovibrio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**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558080505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Paraprevotellaceae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prevotell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58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3.00, -0.16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891146169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447800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E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2. The log fold change (LFC) of absolute abundances for differentially abundant gener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759A2CCF-E1F6-0547-881D-53F385F14C0A}"/>
              </a:ext>
            </a:extLst>
          </p:cNvPr>
          <p:cNvSpPr txBox="1"/>
          <p:nvPr/>
        </p:nvSpPr>
        <p:spPr>
          <a:xfrm>
            <a:off x="423672" y="5562600"/>
            <a:ext cx="8229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The taxon was declared to be significant since the absolute abundance in the group of interest (Time to Develop AIDS &lt; 5 Years) was zero. </a:t>
            </a:r>
          </a:p>
          <a:p>
            <a:r>
              <a:rPr lang="en-US" sz="1400" dirty="0"/>
              <a:t>**NE: not evaluable.</a:t>
            </a:r>
          </a:p>
        </p:txBody>
      </p:sp>
    </p:spTree>
    <p:extLst>
      <p:ext uri="{BB962C8B-B14F-4D97-AF65-F5344CB8AC3E}">
        <p14:creationId xmlns:p14="http://schemas.microsoft.com/office/powerpoint/2010/main" val="310709074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200" y="2000727"/>
          <a:ext cx="8229599" cy="339379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175657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4129887343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5 - 10 Years minus &gt; 10 Years in SC at Visit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u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illonell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tsuokell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51, 3.17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tyrivibrio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38, 2.84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336123078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ibacterium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7, 2.53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19912910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0, 2.30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640849130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auti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32, -0.07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031930233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minococc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mmiger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74, -0.20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2500599606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447800"/>
            <a:ext cx="11888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E (cont’d)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2. The log fold change (LFC) of absolute abundances for differentially abundant genera</a:t>
            </a:r>
          </a:p>
        </p:txBody>
      </p:sp>
    </p:spTree>
    <p:extLst>
      <p:ext uri="{BB962C8B-B14F-4D97-AF65-F5344CB8AC3E}">
        <p14:creationId xmlns:p14="http://schemas.microsoft.com/office/powerpoint/2010/main" val="40902632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3. The log fold change (LFC) of absolute abundances for differentially abundant species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82C56E59-939F-0F4F-9282-BBC491FAEEC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188629"/>
              </p:ext>
            </p:extLst>
          </p:nvPr>
        </p:nvGraphicFramePr>
        <p:xfrm>
          <a:off x="457200" y="1395428"/>
          <a:ext cx="8229600" cy="5349689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371600">
                  <a:extLst>
                    <a:ext uri="{9D8B030D-6E8A-4147-A177-3AD203B41FA5}">
                      <a16:colId xmlns="" xmlns:a16="http://schemas.microsoft.com/office/drawing/2014/main" val="1228644346"/>
                    </a:ext>
                  </a:extLst>
                </a:gridCol>
                <a:gridCol w="1143000">
                  <a:extLst>
                    <a:ext uri="{9D8B030D-6E8A-4147-A177-3AD203B41FA5}">
                      <a16:colId xmlns="" xmlns:a16="http://schemas.microsoft.com/office/drawing/2014/main" val="3831745218"/>
                    </a:ext>
                  </a:extLst>
                </a:gridCol>
                <a:gridCol w="838200">
                  <a:extLst>
                    <a:ext uri="{9D8B030D-6E8A-4147-A177-3AD203B41FA5}">
                      <a16:colId xmlns="" xmlns:a16="http://schemas.microsoft.com/office/drawing/2014/main" val="4235569253"/>
                    </a:ext>
                  </a:extLst>
                </a:gridCol>
                <a:gridCol w="990600">
                  <a:extLst>
                    <a:ext uri="{9D8B030D-6E8A-4147-A177-3AD203B41FA5}">
                      <a16:colId xmlns="" xmlns:a16="http://schemas.microsoft.com/office/drawing/2014/main" val="1184954486"/>
                    </a:ext>
                  </a:extLst>
                </a:gridCol>
                <a:gridCol w="800100">
                  <a:extLst>
                    <a:ext uri="{9D8B030D-6E8A-4147-A177-3AD203B41FA5}">
                      <a16:colId xmlns="" xmlns:a16="http://schemas.microsoft.com/office/drawing/2014/main" val="4006536893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659126051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4043309444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976700242"/>
                    </a:ext>
                  </a:extLst>
                </a:gridCol>
              </a:tblGrid>
              <a:tr h="366051">
                <a:tc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 </a:t>
                      </a:r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minus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NC at visit 1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69407761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en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442805080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votell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votell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rcore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64, 2.34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468353740"/>
                  </a:ext>
                </a:extLst>
              </a:tr>
              <a:tr h="198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acteriu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form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59, 1.59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862561140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riobacter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linsell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ofacien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3, 1.06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132377432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acteriu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olichu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0.66, -0.06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596189829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vibrion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vibri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1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0.87, 0.00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106177408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kenell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istip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derdonki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0.90, -0.09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12648758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minococcus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rqu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15, -0.25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43228901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gil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33, -0.26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76595452"/>
                  </a:ext>
                </a:extLst>
              </a:tr>
              <a:tr h="36789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c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8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43, -0.31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962056223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kenell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istip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utredin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55, -0.27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52338112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rrucomicrob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kermansi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ciniphil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58, -0.36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410223006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iform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65, -0.39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743633081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at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78, -0.54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968584357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98932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4483107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B40FC6E2-3E3C-A74C-9F1B-A99239A3A6E7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200" y="1593625"/>
          <a:ext cx="8229600" cy="451644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295400">
                  <a:extLst>
                    <a:ext uri="{9D8B030D-6E8A-4147-A177-3AD203B41FA5}">
                      <a16:colId xmlns="" xmlns:a16="http://schemas.microsoft.com/office/drawing/2014/main" val="1094502080"/>
                    </a:ext>
                  </a:extLst>
                </a:gridCol>
                <a:gridCol w="1066800">
                  <a:extLst>
                    <a:ext uri="{9D8B030D-6E8A-4147-A177-3AD203B41FA5}">
                      <a16:colId xmlns="" xmlns:a16="http://schemas.microsoft.com/office/drawing/2014/main" val="2696838676"/>
                    </a:ext>
                  </a:extLst>
                </a:gridCol>
                <a:gridCol w="1066800">
                  <a:extLst>
                    <a:ext uri="{9D8B030D-6E8A-4147-A177-3AD203B41FA5}">
                      <a16:colId xmlns="" xmlns:a16="http://schemas.microsoft.com/office/drawing/2014/main" val="2181079376"/>
                    </a:ext>
                  </a:extLst>
                </a:gridCol>
                <a:gridCol w="838200">
                  <a:extLst>
                    <a:ext uri="{9D8B030D-6E8A-4147-A177-3AD203B41FA5}">
                      <a16:colId xmlns="" xmlns:a16="http://schemas.microsoft.com/office/drawing/2014/main" val="1337804322"/>
                    </a:ext>
                  </a:extLst>
                </a:gridCol>
                <a:gridCol w="876300">
                  <a:extLst>
                    <a:ext uri="{9D8B030D-6E8A-4147-A177-3AD203B41FA5}">
                      <a16:colId xmlns="" xmlns:a16="http://schemas.microsoft.com/office/drawing/2014/main" val="2027020969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372805911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12462541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358737647"/>
                    </a:ext>
                  </a:extLst>
                </a:gridCol>
              </a:tblGrid>
              <a:tr h="391324">
                <a:tc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C minus NC at visit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046315373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en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125147489"/>
                  </a:ext>
                </a:extLst>
              </a:tr>
              <a:tr h="21188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acteriu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form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38, 1.82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2118988385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riobacter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linsell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ofacien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8, 1.55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52714929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lleidi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1630-c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2, 1.54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74691190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ore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micigeneran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6, 1.21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64783655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minococcus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avu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9, 1.14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822899902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minococc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tyricicocc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ullicaecoru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15, -0.14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628569898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kenell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istip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derdonkii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21, -0.10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234896653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c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8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63, -0.12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90104227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atu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0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93, -0.25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07375056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kenell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istip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utredini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2.05, -0.23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988699596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62337" y="1189234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3. The log fold change (LFC) of absolute abundances for differentially abundant species</a:t>
            </a:r>
          </a:p>
        </p:txBody>
      </p:sp>
    </p:spTree>
    <p:extLst>
      <p:ext uri="{BB962C8B-B14F-4D97-AF65-F5344CB8AC3E}">
        <p14:creationId xmlns:p14="http://schemas.microsoft.com/office/powerpoint/2010/main" val="320755164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200" y="2000727"/>
          <a:ext cx="8229600" cy="2472082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143000">
                  <a:extLst>
                    <a:ext uri="{9D8B030D-6E8A-4147-A177-3AD203B41FA5}">
                      <a16:colId xmlns="" xmlns:a16="http://schemas.microsoft.com/office/drawing/2014/main" val="487570569"/>
                    </a:ext>
                  </a:extLst>
                </a:gridCol>
                <a:gridCol w="12192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3510074273"/>
                    </a:ext>
                  </a:extLst>
                </a:gridCol>
                <a:gridCol w="9906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876300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Visit 2 minus Visit 1 in SC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en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known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known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known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0.45, -0.12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rphyromonad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bacteroid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stasoni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0.96, 0.00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35197996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auti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beu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21, -0.02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610192372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riobacteri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linsell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ofacien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66, -0.19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119331641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447800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3. The log fold change (LFC) of absolute abundances for differentially abundant species</a:t>
            </a:r>
          </a:p>
        </p:txBody>
      </p:sp>
    </p:spTree>
    <p:extLst>
      <p:ext uri="{BB962C8B-B14F-4D97-AF65-F5344CB8AC3E}">
        <p14:creationId xmlns:p14="http://schemas.microsoft.com/office/powerpoint/2010/main" val="23670565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200" y="2000727"/>
          <a:ext cx="8229600" cy="108950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66800">
                  <a:extLst>
                    <a:ext uri="{9D8B030D-6E8A-4147-A177-3AD203B41FA5}">
                      <a16:colId xmlns="" xmlns:a16="http://schemas.microsoft.com/office/drawing/2014/main" val="260621876"/>
                    </a:ext>
                  </a:extLst>
                </a:gridCol>
                <a:gridCol w="9906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35915150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&lt; 5 Years minus &gt; 10 Years in SC at Visit 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en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ore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micigeneran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-0.7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37, -0.03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447800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3. The log fold change (LFC) of absolute abundances for differentially abundant species</a:t>
            </a:r>
          </a:p>
        </p:txBody>
      </p:sp>
      <p:graphicFrame>
        <p:nvGraphicFramePr>
          <p:cNvPr id="7" name="Content Placeholder 3">
            <a:extLst>
              <a:ext uri="{FF2B5EF4-FFF2-40B4-BE49-F238E27FC236}">
                <a16:creationId xmlns="" xmlns:a16="http://schemas.microsoft.com/office/drawing/2014/main" id="{A36F38CF-02A5-0141-8718-451A170061F3}"/>
              </a:ext>
            </a:extLst>
          </p:cNvPr>
          <p:cNvGraphicFramePr>
            <a:graphicFrameLocks/>
          </p:cNvGraphicFramePr>
          <p:nvPr/>
        </p:nvGraphicFramePr>
        <p:xfrm>
          <a:off x="457199" y="3920583"/>
          <a:ext cx="8229600" cy="108950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295401">
                  <a:extLst>
                    <a:ext uri="{9D8B030D-6E8A-4147-A177-3AD203B41FA5}">
                      <a16:colId xmlns="" xmlns:a16="http://schemas.microsoft.com/office/drawing/2014/main" val="1288766227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876299">
                  <a:extLst>
                    <a:ext uri="{9D8B030D-6E8A-4147-A177-3AD203B41FA5}">
                      <a16:colId xmlns="" xmlns:a16="http://schemas.microsoft.com/office/drawing/2014/main" val="35915150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5 - 10 Years minus &gt; 10 Years in SC at Visit 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en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ostridium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mosu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-0.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E*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53739CA0-F56B-9A4A-9350-43B36D1F3380}"/>
              </a:ext>
            </a:extLst>
          </p:cNvPr>
          <p:cNvSpPr txBox="1"/>
          <p:nvPr/>
        </p:nvSpPr>
        <p:spPr>
          <a:xfrm>
            <a:off x="423672" y="5562600"/>
            <a:ext cx="8229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The taxon was declared to be significant since the absolute abundance in the group of interest (Time to Develop AIDS 5 - 10 Years) was zero. </a:t>
            </a:r>
          </a:p>
          <a:p>
            <a:r>
              <a:rPr lang="en-US" sz="1400" dirty="0"/>
              <a:t>**NE: not evaluable.</a:t>
            </a:r>
          </a:p>
        </p:txBody>
      </p:sp>
    </p:spTree>
    <p:extLst>
      <p:ext uri="{BB962C8B-B14F-4D97-AF65-F5344CB8AC3E}">
        <p14:creationId xmlns:p14="http://schemas.microsoft.com/office/powerpoint/2010/main" val="262703013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175205708"/>
              </p:ext>
            </p:extLst>
          </p:nvPr>
        </p:nvGraphicFramePr>
        <p:xfrm>
          <a:off x="457200" y="2639892"/>
          <a:ext cx="8229600" cy="2011224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447800">
                  <a:extLst>
                    <a:ext uri="{9D8B030D-6E8A-4147-A177-3AD203B41FA5}">
                      <a16:colId xmlns="" xmlns:a16="http://schemas.microsoft.com/office/drawing/2014/main" val="1844517698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1507096185"/>
                    </a:ext>
                  </a:extLst>
                </a:gridCol>
                <a:gridCol w="8382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&lt; 5 Years minus &gt; 10 Years in SC at Visit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en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teroid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gili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27, 3.21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84506079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Eubacterium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lindroid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41, 2.80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739734158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vibrion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vibri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168***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**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4730073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199" y="1693932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E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3. The log fold change (LFC) of absolute abundances for differentially abundant speci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759A2CCF-E1F6-0547-881D-53F385F14C0A}"/>
              </a:ext>
            </a:extLst>
          </p:cNvPr>
          <p:cNvSpPr txBox="1"/>
          <p:nvPr/>
        </p:nvSpPr>
        <p:spPr>
          <a:xfrm>
            <a:off x="453774" y="5473876"/>
            <a:ext cx="8229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*NE: not evaluable.</a:t>
            </a:r>
          </a:p>
          <a:p>
            <a:r>
              <a:rPr lang="en-US" sz="1400" dirty="0"/>
              <a:t>***The taxon was declared to be significant since the absolute abundance in the reference group (Time to Develop AIDS &gt; 10 Years) was zero. </a:t>
            </a:r>
          </a:p>
        </p:txBody>
      </p:sp>
    </p:spTree>
    <p:extLst>
      <p:ext uri="{BB962C8B-B14F-4D97-AF65-F5344CB8AC3E}">
        <p14:creationId xmlns:p14="http://schemas.microsoft.com/office/powerpoint/2010/main" val="257734243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9309875"/>
              </p:ext>
            </p:extLst>
          </p:nvPr>
        </p:nvGraphicFramePr>
        <p:xfrm>
          <a:off x="457200" y="1806092"/>
          <a:ext cx="8229600" cy="339379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295400">
                  <a:extLst>
                    <a:ext uri="{9D8B030D-6E8A-4147-A177-3AD203B41FA5}">
                      <a16:colId xmlns="" xmlns:a16="http://schemas.microsoft.com/office/drawing/2014/main" val="3104280914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876300">
                  <a:extLst>
                    <a:ext uri="{9D8B030D-6E8A-4147-A177-3AD203B41FA5}">
                      <a16:colId xmlns="" xmlns:a16="http://schemas.microsoft.com/office/drawing/2014/main" val="1507096185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028700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5 - 10 Years minus &gt; 10 Years in SC at Visit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en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cie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votell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votell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rcore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38, 4.28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336123078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prococc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tact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42, 2.96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84506079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tyrivibri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ossotu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36, 2.90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52295819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vibrion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vibri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168**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*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942956003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minococc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mmig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micili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8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63, -0.06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5933637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auti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beum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0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3.16, -1.02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1161489778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272291"/>
            <a:ext cx="11888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E (cont’d)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3. The log fold change (LFC) of absolute abundances for differentially abundant speci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759A2CCF-E1F6-0547-881D-53F385F14C0A}"/>
              </a:ext>
            </a:extLst>
          </p:cNvPr>
          <p:cNvSpPr txBox="1"/>
          <p:nvPr/>
        </p:nvSpPr>
        <p:spPr>
          <a:xfrm>
            <a:off x="457199" y="5715000"/>
            <a:ext cx="8229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*NE: not evaluable.</a:t>
            </a:r>
          </a:p>
          <a:p>
            <a:r>
              <a:rPr lang="en-US" sz="1400" dirty="0"/>
              <a:t>***The taxon was declared to be significant since the absolute abundance in the reference group (Time to Develop AIDS &gt; 10 Years) was zero. </a:t>
            </a:r>
          </a:p>
        </p:txBody>
      </p:sp>
    </p:spTree>
    <p:extLst>
      <p:ext uri="{BB962C8B-B14F-4D97-AF65-F5344CB8AC3E}">
        <p14:creationId xmlns:p14="http://schemas.microsoft.com/office/powerpoint/2010/main" val="28762527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B40FC6E2-3E3C-A74C-9F1B-A99239A3A6E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92521943"/>
              </p:ext>
            </p:extLst>
          </p:nvPr>
        </p:nvGraphicFramePr>
        <p:xfrm>
          <a:off x="457200" y="1905000"/>
          <a:ext cx="8229600" cy="37338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524000">
                  <a:extLst>
                    <a:ext uri="{9D8B030D-6E8A-4147-A177-3AD203B41FA5}">
                      <a16:colId xmlns="" xmlns:a16="http://schemas.microsoft.com/office/drawing/2014/main" val="2696838676"/>
                    </a:ext>
                  </a:extLst>
                </a:gridCol>
                <a:gridCol w="1219200">
                  <a:extLst>
                    <a:ext uri="{9D8B030D-6E8A-4147-A177-3AD203B41FA5}">
                      <a16:colId xmlns="" xmlns:a16="http://schemas.microsoft.com/office/drawing/2014/main" val="1337804322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2027020969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372805911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12462541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358737647"/>
                    </a:ext>
                  </a:extLst>
                </a:gridCol>
              </a:tblGrid>
              <a:tr h="391324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C minus NC at visit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046315373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125147489"/>
                  </a:ext>
                </a:extLst>
              </a:tr>
              <a:tr h="21188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S24-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2, 1.72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2118988385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Coriobacteri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3, 1.52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52714929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Pasteurell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0.4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2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0.85, -0.03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74691190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[Odoribacteraceae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-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18, 0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64783655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Veillonell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0.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11, -0.09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822899902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Porphyromonad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0.7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35, -0.11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628569898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Bacteroid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0.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46, -0.14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234896653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[Barnesiellaceae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1.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4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98, -0.37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90104227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33935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1. The log fold change (LFC) of absolute abundances for differentially abundant families</a:t>
            </a:r>
          </a:p>
        </p:txBody>
      </p:sp>
    </p:spTree>
    <p:extLst>
      <p:ext uri="{BB962C8B-B14F-4D97-AF65-F5344CB8AC3E}">
        <p14:creationId xmlns:p14="http://schemas.microsoft.com/office/powerpoint/2010/main" val="38018681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76182984"/>
              </p:ext>
            </p:extLst>
          </p:nvPr>
        </p:nvGraphicFramePr>
        <p:xfrm>
          <a:off x="457200" y="2000727"/>
          <a:ext cx="8229600" cy="1885473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3716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Visit 2 minus Visit 1 in SC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[</a:t>
                      </a:r>
                      <a:r>
                        <a:rPr lang="en-US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Tissierellaceae</a:t>
                      </a:r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5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20, 0.91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Enterococc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3, 0.98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35197996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Coriobacteriacea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-0.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41, -0.02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610192372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9769" y="1447800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1. The log fold change (LFC) of absolute abundances for differentially abundant families</a:t>
            </a:r>
          </a:p>
        </p:txBody>
      </p:sp>
    </p:spTree>
    <p:extLst>
      <p:ext uri="{BB962C8B-B14F-4D97-AF65-F5344CB8AC3E}">
        <p14:creationId xmlns:p14="http://schemas.microsoft.com/office/powerpoint/2010/main" val="31995717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38996590"/>
              </p:ext>
            </p:extLst>
          </p:nvPr>
        </p:nvGraphicFramePr>
        <p:xfrm>
          <a:off x="457200" y="2000727"/>
          <a:ext cx="8229600" cy="963757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3716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&lt; 5 Years minus &gt; 10 Years in SC at Visit 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Veillonell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7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3, 1.40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447800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1. The log fold change (LFC) of absolute abundances for differentially abundant families</a:t>
            </a:r>
          </a:p>
        </p:txBody>
      </p:sp>
    </p:spTree>
    <p:extLst>
      <p:ext uri="{BB962C8B-B14F-4D97-AF65-F5344CB8AC3E}">
        <p14:creationId xmlns:p14="http://schemas.microsoft.com/office/powerpoint/2010/main" val="31188030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45574482"/>
              </p:ext>
            </p:extLst>
          </p:nvPr>
        </p:nvGraphicFramePr>
        <p:xfrm>
          <a:off x="457200" y="2000727"/>
          <a:ext cx="8229600" cy="1424615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3716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&lt; 5 Years minus &gt; 10 Years in SC at Visit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Victivallaceae</a:t>
                      </a:r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E*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votellacea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6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49, 4.04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336123078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9769" y="1392419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E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1. The log fold change (LFC) of absolute abundances for differentially abundant families</a:t>
            </a:r>
          </a:p>
        </p:txBody>
      </p:sp>
      <p:graphicFrame>
        <p:nvGraphicFramePr>
          <p:cNvPr id="7" name="Content Placeholder 3">
            <a:extLst>
              <a:ext uri="{FF2B5EF4-FFF2-40B4-BE49-F238E27FC236}">
                <a16:creationId xmlns="" xmlns:a16="http://schemas.microsoft.com/office/drawing/2014/main" id="{BFE3C32F-3F81-2C43-9B31-55335ABC4C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786571"/>
              </p:ext>
            </p:extLst>
          </p:nvPr>
        </p:nvGraphicFramePr>
        <p:xfrm>
          <a:off x="457200" y="4114800"/>
          <a:ext cx="8229600" cy="963757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3716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371600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to Develop AIDS 5 - 10 Years minus &gt; 10 Years in SC at Visit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Victivallaceae</a:t>
                      </a:r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759A2CCF-E1F6-0547-881D-53F385F14C0A}"/>
              </a:ext>
            </a:extLst>
          </p:cNvPr>
          <p:cNvSpPr txBox="1"/>
          <p:nvPr/>
        </p:nvSpPr>
        <p:spPr>
          <a:xfrm>
            <a:off x="423672" y="5562600"/>
            <a:ext cx="8229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The taxon was declared to be significant since the absolute abundance in the reference group (Time to Develop AIDS &gt; 10 Years) was zero. </a:t>
            </a:r>
          </a:p>
          <a:p>
            <a:r>
              <a:rPr lang="en-US" sz="1400" dirty="0"/>
              <a:t>**NE: not evaluable.</a:t>
            </a:r>
          </a:p>
        </p:txBody>
      </p:sp>
    </p:spTree>
    <p:extLst>
      <p:ext uri="{BB962C8B-B14F-4D97-AF65-F5344CB8AC3E}">
        <p14:creationId xmlns:p14="http://schemas.microsoft.com/office/powerpoint/2010/main" val="14437878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2. The log fold change (LFC) of absolute abundances for differentially abundant genera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82C56E59-939F-0F4F-9282-BBC491FAEECD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200" y="1535239"/>
          <a:ext cx="8229599" cy="4626821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371600">
                  <a:extLst>
                    <a:ext uri="{9D8B030D-6E8A-4147-A177-3AD203B41FA5}">
                      <a16:colId xmlns="" xmlns:a16="http://schemas.microsoft.com/office/drawing/2014/main" val="3831745218"/>
                    </a:ext>
                  </a:extLst>
                </a:gridCol>
                <a:gridCol w="1143000">
                  <a:extLst>
                    <a:ext uri="{9D8B030D-6E8A-4147-A177-3AD203B41FA5}">
                      <a16:colId xmlns="" xmlns:a16="http://schemas.microsoft.com/office/drawing/2014/main" val="2121314730"/>
                    </a:ext>
                  </a:extLst>
                </a:gridCol>
                <a:gridCol w="1012371">
                  <a:extLst>
                    <a:ext uri="{9D8B030D-6E8A-4147-A177-3AD203B41FA5}">
                      <a16:colId xmlns="" xmlns:a16="http://schemas.microsoft.com/office/drawing/2014/main" val="1184954486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4006536893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659126051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4043309444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976700242"/>
                    </a:ext>
                  </a:extLst>
                </a:gridCol>
              </a:tblGrid>
              <a:tr h="366051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 </a:t>
                      </a:r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minus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NC at visit 1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69407761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us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442805080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enibacterium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99, 2.39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468353740"/>
                  </a:ext>
                </a:extLst>
              </a:tr>
              <a:tr h="198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</a:t>
                      </a:r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ogibacteriaceae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ogibacteriu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86, 1.78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862561140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Paraprevotellaceae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Prevotella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53, 2.11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132377432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uccinivibrionacea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uccinivibrio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7, 1.91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596189829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tyrivibri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4, 1.41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106177408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ococc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ococcu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25, 1.27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12648758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lleidi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20, 1.22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43228901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vibrion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vibri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6,  1.28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76595452"/>
                  </a:ext>
                </a:extLst>
              </a:tr>
              <a:tr h="36789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Eubacterium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24, 1.10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962056223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ibacteriu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5, 1.20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52338112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illonell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ascolarctobacteriu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3, 1.18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60219833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03813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0695464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2. The log fold change (LFC) of absolute abundances for differentially abundant genera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82C56E59-939F-0F4F-9282-BBC491FAEECD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200" y="1535239"/>
          <a:ext cx="8229599" cy="4428621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524000">
                  <a:extLst>
                    <a:ext uri="{9D8B030D-6E8A-4147-A177-3AD203B41FA5}">
                      <a16:colId xmlns="" xmlns:a16="http://schemas.microsoft.com/office/drawing/2014/main" val="3831745218"/>
                    </a:ext>
                  </a:extLst>
                </a:gridCol>
                <a:gridCol w="990600">
                  <a:extLst>
                    <a:ext uri="{9D8B030D-6E8A-4147-A177-3AD203B41FA5}">
                      <a16:colId xmlns="" xmlns:a16="http://schemas.microsoft.com/office/drawing/2014/main" val="2121314730"/>
                    </a:ext>
                  </a:extLst>
                </a:gridCol>
                <a:gridCol w="1012371">
                  <a:extLst>
                    <a:ext uri="{9D8B030D-6E8A-4147-A177-3AD203B41FA5}">
                      <a16:colId xmlns="" xmlns:a16="http://schemas.microsoft.com/office/drawing/2014/main" val="1184954486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4006536893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659126051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4043309444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976700242"/>
                    </a:ext>
                  </a:extLst>
                </a:gridCol>
              </a:tblGrid>
              <a:tr h="366051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C </a:t>
                      </a:r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minus</a:t>
                      </a:r>
                      <a:r>
                        <a:rPr lang="en-US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NC at visit 1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69407761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enus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442805080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oriobacteriacea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ollinsell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6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0.11, 1.11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468353740"/>
                  </a:ext>
                </a:extLst>
              </a:tr>
              <a:tr h="198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ethanobacter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ethanobrevibacte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0.04, 1.16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862561140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lostrid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2d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5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0.07, 0.96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132377432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oriobacter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lacki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5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0.09, 0.92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596189829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eillonell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naerovibri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0.03, 0.87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106177408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-75-a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0.01, 0.68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12648758"/>
                  </a:ext>
                </a:extLst>
              </a:tr>
              <a:tr h="3686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esulfovibrion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Bilophil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0.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-1.19, -0.10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43228901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errucomicrob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kkermansi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0.9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-1.59, -0.30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76595452"/>
                  </a:ext>
                </a:extLst>
              </a:tr>
              <a:tr h="36789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Bacteroid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Bacteroid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1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-1.55, -0.47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962056223"/>
                  </a:ext>
                </a:extLst>
              </a:tr>
              <a:tr h="36605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ikenell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listip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-1.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-1.82, -0.54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52338112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038135"/>
            <a:ext cx="1219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 (cont’d)</a:t>
            </a:r>
          </a:p>
        </p:txBody>
      </p:sp>
    </p:spTree>
    <p:extLst>
      <p:ext uri="{BB962C8B-B14F-4D97-AF65-F5344CB8AC3E}">
        <p14:creationId xmlns:p14="http://schemas.microsoft.com/office/powerpoint/2010/main" val="31940727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B40FC6E2-3E3C-A74C-9F1B-A99239A3A6E7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41790" y="1419255"/>
          <a:ext cx="8229599" cy="5299096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463210">
                  <a:extLst>
                    <a:ext uri="{9D8B030D-6E8A-4147-A177-3AD203B41FA5}">
                      <a16:colId xmlns="" xmlns:a16="http://schemas.microsoft.com/office/drawing/2014/main" val="2696838676"/>
                    </a:ext>
                  </a:extLst>
                </a:gridCol>
                <a:gridCol w="1066800">
                  <a:extLst>
                    <a:ext uri="{9D8B030D-6E8A-4147-A177-3AD203B41FA5}">
                      <a16:colId xmlns="" xmlns:a16="http://schemas.microsoft.com/office/drawing/2014/main" val="3861967662"/>
                    </a:ext>
                  </a:extLst>
                </a:gridCol>
                <a:gridCol w="996961">
                  <a:extLst>
                    <a:ext uri="{9D8B030D-6E8A-4147-A177-3AD203B41FA5}">
                      <a16:colId xmlns="" xmlns:a16="http://schemas.microsoft.com/office/drawing/2014/main" val="1337804322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2027020969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372805911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12462541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358737647"/>
                    </a:ext>
                  </a:extLst>
                </a:gridCol>
              </a:tblGrid>
              <a:tr h="391324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C minus NC at visit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046315373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mily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u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125147489"/>
                  </a:ext>
                </a:extLst>
              </a:tr>
              <a:tr h="21188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riobacteriacea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acki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66, 1.56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2118988385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Mogibacteriaceae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gibacteriu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44, 1.62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52714929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enibacteriu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3, 1.89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74691190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riobacter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linsell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6, 1.58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2564783655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lleidi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9, 1.44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822899902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sipelotrich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Eubacterium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5, 1.31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628569898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Ruminococcus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4, 1.13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234896653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minococc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tyricicoccu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14, -0.14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290104227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erostip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16, -0.12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690478342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Odoribacteraceae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doribacte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26, -0.04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306961776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rphyromonad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bacteroid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33, -0.02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882986865"/>
                  </a:ext>
                </a:extLst>
              </a:tr>
              <a:tr h="391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kenell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istip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87, 0.00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3737264771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7200" y="101914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2. The log fold change (LFC) of absolute abundances for differentially abundant genera</a:t>
            </a:r>
          </a:p>
        </p:txBody>
      </p:sp>
    </p:spTree>
    <p:extLst>
      <p:ext uri="{BB962C8B-B14F-4D97-AF65-F5344CB8AC3E}">
        <p14:creationId xmlns:p14="http://schemas.microsoft.com/office/powerpoint/2010/main" val="29057503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="" xmlns:a16="http://schemas.microsoft.com/office/drawing/2014/main" id="{0151F789-E0CC-E146-B2DF-6EFCF75D0D0A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200" y="2000727"/>
          <a:ext cx="8229599" cy="2472082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600200">
                  <a:extLst>
                    <a:ext uri="{9D8B030D-6E8A-4147-A177-3AD203B41FA5}">
                      <a16:colId xmlns="" xmlns:a16="http://schemas.microsoft.com/office/drawing/2014/main" val="3335846943"/>
                    </a:ext>
                  </a:extLst>
                </a:gridCol>
                <a:gridCol w="1143000">
                  <a:extLst>
                    <a:ext uri="{9D8B030D-6E8A-4147-A177-3AD203B41FA5}">
                      <a16:colId xmlns="" xmlns:a16="http://schemas.microsoft.com/office/drawing/2014/main" val="2533341283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969630747"/>
                    </a:ext>
                  </a:extLst>
                </a:gridCol>
                <a:gridCol w="1045028">
                  <a:extLst>
                    <a:ext uri="{9D8B030D-6E8A-4147-A177-3AD203B41FA5}">
                      <a16:colId xmlns="" xmlns:a16="http://schemas.microsoft.com/office/drawing/2014/main" val="51316535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651060303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2068661149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1997007325"/>
                    </a:ext>
                  </a:extLst>
                </a:gridCol>
              </a:tblGrid>
              <a:tr h="249534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Visit 2 minus Visit 1 in SC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81796031"/>
                  </a:ext>
                </a:extLst>
              </a:tr>
              <a:tr h="249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us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F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usted p-value (BH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006167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Paraprevotellaceae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prevotell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0, 1.59]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53660547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anobacter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anosphaer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11, 0.85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351979966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luviitale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0.02, 0.67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610192372"/>
                  </a:ext>
                </a:extLst>
              </a:tr>
              <a:tr h="4608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riobacteriacea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linsell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-1.51, -0.05]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4067419111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59769" y="1447800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sp>
        <p:nvSpPr>
          <p:cNvPr id="6" name="Title 1">
            <a:extLst>
              <a:ext uri="{FF2B5EF4-FFF2-40B4-BE49-F238E27FC236}">
                <a16:creationId xmlns="" xmlns:a16="http://schemas.microsoft.com/office/drawing/2014/main" id="{2BED1A9D-0402-184D-ABF3-99A4AE22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1143000"/>
          </a:xfrm>
        </p:spPr>
        <p:txBody>
          <a:bodyPr>
            <a:noAutofit/>
          </a:bodyPr>
          <a:lstStyle/>
          <a:p>
            <a:r>
              <a:rPr lang="en-US" sz="2400" b="1" dirty="0"/>
              <a:t>Supplementary Table 2. The log fold change (LFC) of absolute abundances for differentially abundant genera</a:t>
            </a:r>
          </a:p>
        </p:txBody>
      </p:sp>
    </p:spTree>
    <p:extLst>
      <p:ext uri="{BB962C8B-B14F-4D97-AF65-F5344CB8AC3E}">
        <p14:creationId xmlns:p14="http://schemas.microsoft.com/office/powerpoint/2010/main" val="1484545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20</TotalTime>
  <Words>2346</Words>
  <Application>Microsoft Office PowerPoint</Application>
  <PresentationFormat>On-screen Show (4:3)</PresentationFormat>
  <Paragraphs>1004</Paragraphs>
  <Slides>1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19" baseType="lpstr">
      <vt:lpstr>Office Theme</vt:lpstr>
      <vt:lpstr>Supplementary Table 1. The log fold change (LFC) of absolute abundances for differentially abundant families</vt:lpstr>
      <vt:lpstr>Supplementary Table 1. The log fold change (LFC) of absolute abundances for differentially abundant families</vt:lpstr>
      <vt:lpstr>Supplementary Table 1. The log fold change (LFC) of absolute abundances for differentially abundant families</vt:lpstr>
      <vt:lpstr>Supplementary Table 1. The log fold change (LFC) of absolute abundances for differentially abundant families</vt:lpstr>
      <vt:lpstr>Supplementary Table 1. The log fold change (LFC) of absolute abundances for differentially abundant families</vt:lpstr>
      <vt:lpstr>Supplementary Table 2. The log fold change (LFC) of absolute abundances for differentially abundant genera</vt:lpstr>
      <vt:lpstr>Supplementary Table 2. The log fold change (LFC) of absolute abundances for differentially abundant genera</vt:lpstr>
      <vt:lpstr>Supplementary Table 2. The log fold change (LFC) of absolute abundances for differentially abundant genera</vt:lpstr>
      <vt:lpstr>Supplementary Table 2. The log fold change (LFC) of absolute abundances for differentially abundant genera</vt:lpstr>
      <vt:lpstr>Supplementary Table 2. The log fold change (LFC) of absolute abundances for differentially abundant genera</vt:lpstr>
      <vt:lpstr>Supplementary Table 2. The log fold change (LFC) of absolute abundances for differentially abundant genera</vt:lpstr>
      <vt:lpstr>Supplementary Table 2. The log fold change (LFC) of absolute abundances for differentially abundant genera</vt:lpstr>
      <vt:lpstr>Supplementary Table 3. The log fold change (LFC) of absolute abundances for differentially abundant species</vt:lpstr>
      <vt:lpstr>Supplementary Table 3. The log fold change (LFC) of absolute abundances for differentially abundant species</vt:lpstr>
      <vt:lpstr>Supplementary Table 3. The log fold change (LFC) of absolute abundances for differentially abundant species</vt:lpstr>
      <vt:lpstr>Supplementary Table 3. The log fold change (LFC) of absolute abundances for differentially abundant species</vt:lpstr>
      <vt:lpstr>Supplementary Table 3. The log fold change (LFC) of absolute abundances for differentially abundant species</vt:lpstr>
      <vt:lpstr>Supplementary Table 3. The log fold change (LFC) of absolute abundances for differentially abundant speci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e Chen</dc:creator>
  <cp:lastModifiedBy>Yue</cp:lastModifiedBy>
  <cp:revision>523</cp:revision>
  <dcterms:created xsi:type="dcterms:W3CDTF">2020-08-15T13:00:34Z</dcterms:created>
  <dcterms:modified xsi:type="dcterms:W3CDTF">2021-08-24T01:31:12Z</dcterms:modified>
</cp:coreProperties>
</file>